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8D3ACF-26E0-46B9-85AE-9BC9652D324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575C58-D6F3-458B-84B0-D427E97B79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FF9768-D095-40C9-B887-818E72F4975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BBE9DE-3193-4EA6-890E-92E7654704F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138867-7E7C-48CE-9641-71D3D49CE9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B0019D-9B49-48E4-9539-2D836A26EB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866CD1-B2B1-4F80-B1CB-31F62C4707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238AC6-1306-41B7-909B-6D05CC2745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010A4A-1854-4498-942C-0132FF371C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DA673B-FD09-4941-B583-ED28387D3E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0FC22B-AF01-4976-ACBA-1E61EB91DD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2D5E49-41EE-4E8D-9E75-825BD79292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EE2284-C0F0-4F14-BF9B-1FD3C8A5BBB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wmf"/><Relationship Id="rId4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-504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Supplemental Figure 1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690480" y="1523880"/>
            <a:ext cx="3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268520" y="1523880"/>
            <a:ext cx="3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268880" y="380988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" descr=""/>
          <p:cNvPicPr/>
          <p:nvPr/>
        </p:nvPicPr>
        <p:blipFill>
          <a:blip r:embed="rId1"/>
          <a:srcRect l="7463" t="6322" r="4973" b="5066"/>
          <a:stretch/>
        </p:blipFill>
        <p:spPr>
          <a:xfrm>
            <a:off x="4978440" y="1281240"/>
            <a:ext cx="3354480" cy="2543040"/>
          </a:xfrm>
          <a:prstGeom prst="rect">
            <a:avLst/>
          </a:prstGeom>
          <a:ln w="0">
            <a:noFill/>
          </a:ln>
        </p:spPr>
      </p:pic>
      <p:grpSp>
        <p:nvGrpSpPr>
          <p:cNvPr id="46" name=""/>
          <p:cNvGrpSpPr/>
          <p:nvPr/>
        </p:nvGrpSpPr>
        <p:grpSpPr>
          <a:xfrm>
            <a:off x="4554360" y="1405080"/>
            <a:ext cx="3813480" cy="2443320"/>
            <a:chOff x="4554360" y="1405080"/>
            <a:chExt cx="3813480" cy="2443320"/>
          </a:xfrm>
        </p:grpSpPr>
        <p:sp>
          <p:nvSpPr>
            <p:cNvPr id="47" name=""/>
            <p:cNvSpPr/>
            <p:nvPr/>
          </p:nvSpPr>
          <p:spPr>
            <a:xfrm>
              <a:off x="5022720" y="3666960"/>
              <a:ext cx="835200" cy="152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K-8776 (</a:t>
              </a:r>
              <a:r>
                <a:rPr b="0" lang="el-GR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μ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7075440" y="3695760"/>
              <a:ext cx="835200" cy="152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K-1775 (</a:t>
              </a:r>
              <a:r>
                <a:rPr b="0" lang="el-GR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μ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299200" y="3157560"/>
              <a:ext cx="7776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460840" y="3300480"/>
              <a:ext cx="21132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699160" y="3438360"/>
              <a:ext cx="21096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5937120" y="3552840"/>
              <a:ext cx="23976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.0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6294600" y="3657600"/>
              <a:ext cx="134640" cy="136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6499080" y="3676680"/>
              <a:ext cx="135000" cy="136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6970680" y="3529080"/>
              <a:ext cx="23976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.0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7313760" y="3438360"/>
              <a:ext cx="2394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.0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7780320" y="3338640"/>
              <a:ext cx="1872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8180280" y="3205080"/>
              <a:ext cx="18756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013360" y="3071880"/>
              <a:ext cx="135000" cy="136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7599240" y="3386160"/>
              <a:ext cx="135000" cy="136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rot="10800000">
              <a:off x="4900680" y="1742760"/>
              <a:ext cx="95040" cy="1299960"/>
            </a:xfrm>
            <a:prstGeom prst="rtTriangl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rot="16200000">
              <a:off x="4289400" y="2223720"/>
              <a:ext cx="834840" cy="30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ractional prolifer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339520" y="1405080"/>
              <a:ext cx="62424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205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ell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64" name="" descr=""/>
          <p:cNvPicPr/>
          <p:nvPr/>
        </p:nvPicPr>
        <p:blipFill>
          <a:blip r:embed="rId2"/>
          <a:srcRect l="7463" t="6322" r="4973" b="5066"/>
          <a:stretch/>
        </p:blipFill>
        <p:spPr>
          <a:xfrm>
            <a:off x="4978440" y="4156200"/>
            <a:ext cx="3354480" cy="2543040"/>
          </a:xfrm>
          <a:prstGeom prst="rect">
            <a:avLst/>
          </a:prstGeom>
          <a:ln w="0">
            <a:noFill/>
          </a:ln>
        </p:spPr>
      </p:pic>
      <p:sp>
        <p:nvSpPr>
          <p:cNvPr id="65" name=""/>
          <p:cNvSpPr/>
          <p:nvPr/>
        </p:nvSpPr>
        <p:spPr>
          <a:xfrm>
            <a:off x="5022720" y="6537240"/>
            <a:ext cx="835200" cy="152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K-8776 (</a:t>
            </a:r>
            <a:r>
              <a:rPr b="0" lang="el-GR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7075440" y="6566040"/>
            <a:ext cx="835200" cy="152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K-1775 (</a:t>
            </a:r>
            <a:r>
              <a:rPr b="0" lang="el-GR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5299200" y="6027840"/>
            <a:ext cx="7776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5460840" y="6170760"/>
            <a:ext cx="21132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5699160" y="6308640"/>
            <a:ext cx="21096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.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937120" y="6423120"/>
            <a:ext cx="23976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.0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6294600" y="6527880"/>
            <a:ext cx="134640" cy="136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6499080" y="6546960"/>
            <a:ext cx="135000" cy="136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6970680" y="6399360"/>
            <a:ext cx="23976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.0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7313760" y="6308640"/>
            <a:ext cx="2394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.0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7780320" y="6208560"/>
            <a:ext cx="1872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8180280" y="6075360"/>
            <a:ext cx="18756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5013360" y="5942160"/>
            <a:ext cx="135000" cy="136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7599240" y="6256440"/>
            <a:ext cx="135000" cy="136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rot="10800000">
            <a:off x="4900680" y="4613040"/>
            <a:ext cx="95040" cy="1299960"/>
          </a:xfrm>
          <a:prstGeom prst="rtTriangl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rot="16200000">
            <a:off x="4289040" y="5094000"/>
            <a:ext cx="835200" cy="304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ractional 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5340240" y="4313160"/>
            <a:ext cx="555480" cy="45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PL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" descr=""/>
          <p:cNvPicPr/>
          <p:nvPr/>
        </p:nvPicPr>
        <p:blipFill>
          <a:blip r:embed="rId3"/>
          <a:stretch/>
        </p:blipFill>
        <p:spPr>
          <a:xfrm>
            <a:off x="1401840" y="1243080"/>
            <a:ext cx="1931760" cy="5487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2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6T13:05:12Z</dcterms:created>
  <dc:creator>Shumway</dc:creator>
  <dc:description/>
  <dc:language>en-US</dc:language>
  <cp:lastModifiedBy>Shumway</cp:lastModifiedBy>
  <dcterms:modified xsi:type="dcterms:W3CDTF">2012-10-26T12:31:34Z</dcterms:modified>
  <cp:revision>195</cp:revision>
  <dc:subject/>
  <dc:title>Draft figures for Wee + CHK manuscript</dc:title>
</cp:coreProperties>
</file>